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1335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154"/>
    <p:restoredTop sz="94694"/>
  </p:normalViewPr>
  <p:slideViewPr>
    <p:cSldViewPr snapToGrid="0" snapToObjects="1">
      <p:cViewPr varScale="1">
        <p:scale>
          <a:sx n="65" d="100"/>
          <a:sy n="65" d="100"/>
        </p:scale>
        <p:origin x="253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69923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0216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923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4987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994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7815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940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238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29810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643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6780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2999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3E9CA9E-4116-2B97-01A5-33E81BA341F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4983" t="12162" r="19045" b="22211"/>
          <a:stretch/>
        </p:blipFill>
        <p:spPr>
          <a:xfrm>
            <a:off x="673804" y="2101325"/>
            <a:ext cx="2597708" cy="164982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FCB5564-14BA-84C7-9754-4211FC72A1C6}"/>
              </a:ext>
            </a:extLst>
          </p:cNvPr>
          <p:cNvSpPr txBox="1"/>
          <p:nvPr/>
        </p:nvSpPr>
        <p:spPr>
          <a:xfrm>
            <a:off x="232133" y="2400647"/>
            <a:ext cx="511679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PGM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9F6ADB2-20D0-7334-F005-6DF965878AD8}"/>
              </a:ext>
            </a:extLst>
          </p:cNvPr>
          <p:cNvSpPr txBox="1"/>
          <p:nvPr/>
        </p:nvSpPr>
        <p:spPr>
          <a:xfrm rot="18990905">
            <a:off x="1031807" y="1701013"/>
            <a:ext cx="530915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HupT3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D4D79CD-35F1-2B31-0F7E-66BEE6044516}"/>
              </a:ext>
            </a:extLst>
          </p:cNvPr>
          <p:cNvSpPr txBox="1"/>
          <p:nvPr/>
        </p:nvSpPr>
        <p:spPr>
          <a:xfrm rot="18990905">
            <a:off x="1212678" y="1677002"/>
            <a:ext cx="646331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Tu8988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5C00FB9-E9D2-C61F-23F4-BE78FFC8C588}"/>
              </a:ext>
            </a:extLst>
          </p:cNvPr>
          <p:cNvSpPr txBox="1"/>
          <p:nvPr/>
        </p:nvSpPr>
        <p:spPr>
          <a:xfrm rot="18990905">
            <a:off x="1471697" y="1701915"/>
            <a:ext cx="562975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ASPC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2C65BC8-69BF-03AC-19EB-B1BA3EE2A0DB}"/>
              </a:ext>
            </a:extLst>
          </p:cNvPr>
          <p:cNvSpPr txBox="1"/>
          <p:nvPr/>
        </p:nvSpPr>
        <p:spPr>
          <a:xfrm rot="18990905">
            <a:off x="1713613" y="1701013"/>
            <a:ext cx="518091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DAN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713CF1C-142E-8039-8D2F-E2D0DFEB4227}"/>
              </a:ext>
            </a:extLst>
          </p:cNvPr>
          <p:cNvSpPr txBox="1"/>
          <p:nvPr/>
        </p:nvSpPr>
        <p:spPr>
          <a:xfrm rot="18990905">
            <a:off x="1961974" y="1666791"/>
            <a:ext cx="595035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TU890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922A768-56C1-99A3-D55B-6CDCF1537336}"/>
              </a:ext>
            </a:extLst>
          </p:cNvPr>
          <p:cNvSpPr txBox="1"/>
          <p:nvPr/>
        </p:nvSpPr>
        <p:spPr>
          <a:xfrm rot="18990905">
            <a:off x="2176037" y="1663481"/>
            <a:ext cx="671979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TU8988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3614F1B-8CC0-F6D9-896D-A88A159E866C}"/>
              </a:ext>
            </a:extLst>
          </p:cNvPr>
          <p:cNvSpPr txBox="1"/>
          <p:nvPr/>
        </p:nvSpPr>
        <p:spPr>
          <a:xfrm rot="18990905">
            <a:off x="2405546" y="1668188"/>
            <a:ext cx="684803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CAPAN-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1D90AB8-71AB-D81C-AA01-BFF462FCA489}"/>
              </a:ext>
            </a:extLst>
          </p:cNvPr>
          <p:cNvSpPr txBox="1"/>
          <p:nvPr/>
        </p:nvSpPr>
        <p:spPr>
          <a:xfrm rot="18990905">
            <a:off x="2638991" y="1636905"/>
            <a:ext cx="761747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MiaPaCa-2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8DA105B1-FE04-3FF7-7EAF-8B5BF5BF715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0565" t="56694" r="22589" b="18401"/>
          <a:stretch/>
        </p:blipFill>
        <p:spPr>
          <a:xfrm>
            <a:off x="665384" y="3819531"/>
            <a:ext cx="2597708" cy="616487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5E31A05D-F675-BAD1-0488-AE90FA63B225}"/>
              </a:ext>
            </a:extLst>
          </p:cNvPr>
          <p:cNvSpPr txBox="1"/>
          <p:nvPr/>
        </p:nvSpPr>
        <p:spPr>
          <a:xfrm>
            <a:off x="154399" y="3931567"/>
            <a:ext cx="588623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FBD77C5-E466-B1BB-21B9-C91D959DBF73}"/>
              </a:ext>
            </a:extLst>
          </p:cNvPr>
          <p:cNvSpPr txBox="1"/>
          <p:nvPr/>
        </p:nvSpPr>
        <p:spPr>
          <a:xfrm>
            <a:off x="1555829" y="1196354"/>
            <a:ext cx="742511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UPP1-hig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2110508-EC92-67E4-047E-8DE96CC40584}"/>
              </a:ext>
            </a:extLst>
          </p:cNvPr>
          <p:cNvSpPr txBox="1"/>
          <p:nvPr/>
        </p:nvSpPr>
        <p:spPr>
          <a:xfrm>
            <a:off x="2603515" y="1198391"/>
            <a:ext cx="697627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UPP1-low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D8DA95F7-DBF8-3721-FF4E-7B211500C274}"/>
              </a:ext>
            </a:extLst>
          </p:cNvPr>
          <p:cNvCxnSpPr>
            <a:cxnSpLocks/>
          </p:cNvCxnSpPr>
          <p:nvPr/>
        </p:nvCxnSpPr>
        <p:spPr>
          <a:xfrm>
            <a:off x="1240947" y="1414154"/>
            <a:ext cx="1210607" cy="1355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DD767104-826E-6D9F-C598-DBDD32AFC0EB}"/>
              </a:ext>
            </a:extLst>
          </p:cNvPr>
          <p:cNvCxnSpPr>
            <a:cxnSpLocks/>
          </p:cNvCxnSpPr>
          <p:nvPr/>
        </p:nvCxnSpPr>
        <p:spPr>
          <a:xfrm>
            <a:off x="2568899" y="1426281"/>
            <a:ext cx="69587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98F4E979-A47D-9A62-B73F-C80667D73ED0}"/>
              </a:ext>
            </a:extLst>
          </p:cNvPr>
          <p:cNvSpPr txBox="1"/>
          <p:nvPr/>
        </p:nvSpPr>
        <p:spPr>
          <a:xfrm>
            <a:off x="3188668" y="1879030"/>
            <a:ext cx="45717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~kD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51568AE-7BAC-21E4-BC93-4DB87589BBAE}"/>
              </a:ext>
            </a:extLst>
          </p:cNvPr>
          <p:cNvSpPr txBox="1"/>
          <p:nvPr/>
        </p:nvSpPr>
        <p:spPr>
          <a:xfrm>
            <a:off x="3260202" y="2407346"/>
            <a:ext cx="31290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68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CF01887-76A0-1D51-1559-9A191D179BA5}"/>
              </a:ext>
            </a:extLst>
          </p:cNvPr>
          <p:cNvSpPr txBox="1"/>
          <p:nvPr/>
        </p:nvSpPr>
        <p:spPr>
          <a:xfrm>
            <a:off x="3236188" y="3938266"/>
            <a:ext cx="37702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2639A733-74CC-1B55-1FFD-E61908DCEB89}"/>
              </a:ext>
            </a:extLst>
          </p:cNvPr>
          <p:cNvSpPr/>
          <p:nvPr/>
        </p:nvSpPr>
        <p:spPr>
          <a:xfrm>
            <a:off x="1040083" y="2362643"/>
            <a:ext cx="1894968" cy="271373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308FCD56-D84F-8A45-90D3-AA1614ABE1C9}"/>
              </a:ext>
            </a:extLst>
          </p:cNvPr>
          <p:cNvSpPr/>
          <p:nvPr/>
        </p:nvSpPr>
        <p:spPr>
          <a:xfrm>
            <a:off x="1065120" y="3901256"/>
            <a:ext cx="1894968" cy="271373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56096A4-B349-AD94-E69F-E930FD267F14}"/>
              </a:ext>
            </a:extLst>
          </p:cNvPr>
          <p:cNvSpPr txBox="1"/>
          <p:nvPr/>
        </p:nvSpPr>
        <p:spPr>
          <a:xfrm>
            <a:off x="209903" y="166613"/>
            <a:ext cx="7132320" cy="5632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3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. </a:t>
            </a:r>
            <a:r>
              <a:rPr lang="en-US" sz="1530" dirty="0">
                <a:latin typeface="Arial" panose="020B0604020202020204" pitchFamily="34" charset="0"/>
                <a:cs typeface="Arial" panose="020B0604020202020204" pitchFamily="34" charset="0"/>
              </a:rPr>
              <a:t>Full, uncropped western image for Extended Data Figure 4i.</a:t>
            </a:r>
          </a:p>
        </p:txBody>
      </p:sp>
    </p:spTree>
    <p:extLst>
      <p:ext uri="{BB962C8B-B14F-4D97-AF65-F5344CB8AC3E}">
        <p14:creationId xmlns:p14="http://schemas.microsoft.com/office/powerpoint/2010/main" val="5217861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845</TotalTime>
  <Words>31</Words>
  <Application>Microsoft Office PowerPoint</Application>
  <PresentationFormat>Custom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tton, Damien</dc:creator>
  <cp:lastModifiedBy>Lyssiotis, Costas</cp:lastModifiedBy>
  <cp:revision>27</cp:revision>
  <dcterms:created xsi:type="dcterms:W3CDTF">2022-08-08T03:19:06Z</dcterms:created>
  <dcterms:modified xsi:type="dcterms:W3CDTF">2023-03-31T02:45:38Z</dcterms:modified>
</cp:coreProperties>
</file>